
<file path=[Content_Types].xml><?xml version="1.0" encoding="utf-8"?>
<Types xmlns="http://schemas.openxmlformats.org/package/2006/content-types">
  <Default Extension="png" ContentType="image/png"/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6" r:id="rId3"/>
    <p:sldId id="260" r:id="rId4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1" d="100"/>
          <a:sy n="71" d="100"/>
        </p:scale>
        <p:origin x="129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9A8A0-8FA3-47B3-A467-4007182AC074}" type="datetimeFigureOut">
              <a:rPr lang="es-ES" smtClean="0"/>
              <a:t>14/07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6B072B-19E8-435D-A908-1859A9460FB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75622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9A8A0-8FA3-47B3-A467-4007182AC074}" type="datetimeFigureOut">
              <a:rPr lang="es-ES" smtClean="0"/>
              <a:t>14/07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6B072B-19E8-435D-A908-1859A9460FB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562280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9A8A0-8FA3-47B3-A467-4007182AC074}" type="datetimeFigureOut">
              <a:rPr lang="es-ES" smtClean="0"/>
              <a:t>14/07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6B072B-19E8-435D-A908-1859A9460FB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286679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9A8A0-8FA3-47B3-A467-4007182AC074}" type="datetimeFigureOut">
              <a:rPr lang="es-ES" smtClean="0"/>
              <a:t>14/07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6B072B-19E8-435D-A908-1859A9460FB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193150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9A8A0-8FA3-47B3-A467-4007182AC074}" type="datetimeFigureOut">
              <a:rPr lang="es-ES" smtClean="0"/>
              <a:t>14/07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6B072B-19E8-435D-A908-1859A9460FB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040313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9A8A0-8FA3-47B3-A467-4007182AC074}" type="datetimeFigureOut">
              <a:rPr lang="es-ES" smtClean="0"/>
              <a:t>14/07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6B072B-19E8-435D-A908-1859A9460FB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715963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9A8A0-8FA3-47B3-A467-4007182AC074}" type="datetimeFigureOut">
              <a:rPr lang="es-ES" smtClean="0"/>
              <a:t>14/07/2021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6B072B-19E8-435D-A908-1859A9460FB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846225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9A8A0-8FA3-47B3-A467-4007182AC074}" type="datetimeFigureOut">
              <a:rPr lang="es-ES" smtClean="0"/>
              <a:t>14/07/2021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6B072B-19E8-435D-A908-1859A9460FB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874797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9A8A0-8FA3-47B3-A467-4007182AC074}" type="datetimeFigureOut">
              <a:rPr lang="es-ES" smtClean="0"/>
              <a:t>14/07/2021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6B072B-19E8-435D-A908-1859A9460FB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169766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9A8A0-8FA3-47B3-A467-4007182AC074}" type="datetimeFigureOut">
              <a:rPr lang="es-ES" smtClean="0"/>
              <a:t>14/07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6B072B-19E8-435D-A908-1859A9460FB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211715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9A8A0-8FA3-47B3-A467-4007182AC074}" type="datetimeFigureOut">
              <a:rPr lang="es-ES" smtClean="0"/>
              <a:t>14/07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6B072B-19E8-435D-A908-1859A9460FB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244968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D9A8A0-8FA3-47B3-A467-4007182AC074}" type="datetimeFigureOut">
              <a:rPr lang="es-ES" smtClean="0"/>
              <a:t>14/07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6B072B-19E8-435D-A908-1859A9460FB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967802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w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upo 6"/>
          <p:cNvGrpSpPr/>
          <p:nvPr/>
        </p:nvGrpSpPr>
        <p:grpSpPr>
          <a:xfrm>
            <a:off x="500407" y="1709113"/>
            <a:ext cx="6594639" cy="4305300"/>
            <a:chOff x="500407" y="1709113"/>
            <a:chExt cx="6594639" cy="4305300"/>
          </a:xfrm>
        </p:grpSpPr>
        <p:grpSp>
          <p:nvGrpSpPr>
            <p:cNvPr id="5" name="Grupo 4"/>
            <p:cNvGrpSpPr/>
            <p:nvPr/>
          </p:nvGrpSpPr>
          <p:grpSpPr>
            <a:xfrm>
              <a:off x="500407" y="1709113"/>
              <a:ext cx="4947333" cy="4305300"/>
              <a:chOff x="500407" y="1657350"/>
              <a:chExt cx="4947333" cy="4305300"/>
            </a:xfrm>
          </p:grpSpPr>
          <p:grpSp>
            <p:nvGrpSpPr>
              <p:cNvPr id="15" name="Grupo 14"/>
              <p:cNvGrpSpPr/>
              <p:nvPr/>
            </p:nvGrpSpPr>
            <p:grpSpPr>
              <a:xfrm>
                <a:off x="952500" y="1657350"/>
                <a:ext cx="4495240" cy="4305300"/>
                <a:chOff x="952500" y="1657350"/>
                <a:chExt cx="4495240" cy="4305300"/>
              </a:xfrm>
            </p:grpSpPr>
            <p:pic>
              <p:nvPicPr>
                <p:cNvPr id="4" name="Imagen 3"/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952500" y="1657350"/>
                  <a:ext cx="4495240" cy="4305300"/>
                </a:xfrm>
                <a:prstGeom prst="rect">
                  <a:avLst/>
                </a:prstGeom>
              </p:spPr>
            </p:pic>
            <p:sp>
              <p:nvSpPr>
                <p:cNvPr id="14" name="Rectángulo 13"/>
                <p:cNvSpPr/>
                <p:nvPr/>
              </p:nvSpPr>
              <p:spPr>
                <a:xfrm>
                  <a:off x="4826442" y="1852654"/>
                  <a:ext cx="381662" cy="652007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/>
                </a:p>
              </p:txBody>
            </p:sp>
          </p:grpSp>
          <p:sp>
            <p:nvSpPr>
              <p:cNvPr id="17" name="CuadroTexto 16"/>
              <p:cNvSpPr txBox="1"/>
              <p:nvPr/>
            </p:nvSpPr>
            <p:spPr>
              <a:xfrm rot="16200000">
                <a:off x="-156600" y="3583797"/>
                <a:ext cx="159101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200" dirty="0" smtClean="0"/>
                  <a:t>Principal </a:t>
                </a:r>
                <a:r>
                  <a:rPr lang="es-ES" sz="1200" dirty="0" err="1" smtClean="0"/>
                  <a:t>component</a:t>
                </a:r>
                <a:r>
                  <a:rPr lang="es-ES" sz="1200" dirty="0" smtClean="0"/>
                  <a:t> 2</a:t>
                </a:r>
                <a:endParaRPr lang="es-ES" sz="1200" dirty="0"/>
              </a:p>
            </p:txBody>
          </p:sp>
          <p:sp>
            <p:nvSpPr>
              <p:cNvPr id="16" name="CuadroTexto 15"/>
              <p:cNvSpPr txBox="1"/>
              <p:nvPr/>
            </p:nvSpPr>
            <p:spPr>
              <a:xfrm>
                <a:off x="2595002" y="5685651"/>
                <a:ext cx="1591013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s-ES" sz="1200" dirty="0" smtClean="0"/>
                  <a:t>Principal </a:t>
                </a:r>
                <a:r>
                  <a:rPr lang="es-ES" sz="1200" dirty="0" err="1" smtClean="0"/>
                  <a:t>component</a:t>
                </a:r>
                <a:r>
                  <a:rPr lang="es-ES" sz="1200" dirty="0" smtClean="0"/>
                  <a:t> 1</a:t>
                </a:r>
                <a:endParaRPr lang="es-ES" sz="1200" dirty="0"/>
              </a:p>
            </p:txBody>
          </p:sp>
        </p:grpSp>
        <p:grpSp>
          <p:nvGrpSpPr>
            <p:cNvPr id="6" name="Grupo 5"/>
            <p:cNvGrpSpPr/>
            <p:nvPr/>
          </p:nvGrpSpPr>
          <p:grpSpPr>
            <a:xfrm>
              <a:off x="5447740" y="3462084"/>
              <a:ext cx="1647306" cy="954107"/>
              <a:chOff x="2618041" y="5845109"/>
              <a:chExt cx="1647306" cy="954107"/>
            </a:xfrm>
          </p:grpSpPr>
          <p:sp>
            <p:nvSpPr>
              <p:cNvPr id="8" name="Elipse 7"/>
              <p:cNvSpPr/>
              <p:nvPr/>
            </p:nvSpPr>
            <p:spPr>
              <a:xfrm>
                <a:off x="2618041" y="6006731"/>
                <a:ext cx="72008" cy="45719"/>
              </a:xfrm>
              <a:prstGeom prst="ellipse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9" name="CuadroTexto 8"/>
              <p:cNvSpPr txBox="1"/>
              <p:nvPr/>
            </p:nvSpPr>
            <p:spPr>
              <a:xfrm>
                <a:off x="2718705" y="5845109"/>
                <a:ext cx="1546642" cy="95410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400" dirty="0" err="1" smtClean="0"/>
                  <a:t>Europeans</a:t>
                </a:r>
                <a:endParaRPr lang="es-ES" sz="1400" dirty="0" smtClean="0"/>
              </a:p>
              <a:p>
                <a:r>
                  <a:rPr lang="es-ES" sz="1400" dirty="0" smtClean="0"/>
                  <a:t>GWAS </a:t>
                </a:r>
                <a:r>
                  <a:rPr lang="es-ES" sz="1400" dirty="0" err="1" smtClean="0"/>
                  <a:t>population</a:t>
                </a:r>
                <a:endParaRPr lang="es-ES" sz="1400" dirty="0" smtClean="0"/>
              </a:p>
              <a:p>
                <a:r>
                  <a:rPr lang="es-ES" sz="1400" dirty="0" smtClean="0"/>
                  <a:t>South </a:t>
                </a:r>
                <a:r>
                  <a:rPr lang="es-ES" sz="1400" dirty="0" err="1" smtClean="0"/>
                  <a:t>Americans</a:t>
                </a:r>
                <a:endParaRPr lang="es-ES" sz="1400" dirty="0" smtClean="0"/>
              </a:p>
              <a:p>
                <a:r>
                  <a:rPr lang="es-ES" sz="1400" dirty="0" smtClean="0"/>
                  <a:t>South-West </a:t>
                </a:r>
                <a:r>
                  <a:rPr lang="es-ES" sz="1400" dirty="0" err="1" smtClean="0"/>
                  <a:t>Asians</a:t>
                </a:r>
                <a:endParaRPr lang="es-ES" sz="1400" dirty="0"/>
              </a:p>
            </p:txBody>
          </p:sp>
          <p:sp>
            <p:nvSpPr>
              <p:cNvPr id="10" name="Elipse 9"/>
              <p:cNvSpPr/>
              <p:nvPr/>
            </p:nvSpPr>
            <p:spPr>
              <a:xfrm>
                <a:off x="2618041" y="6409164"/>
                <a:ext cx="72008" cy="45719"/>
              </a:xfrm>
              <a:prstGeom prst="ellipse">
                <a:avLst/>
              </a:prstGeom>
              <a:solidFill>
                <a:srgbClr val="FFC000"/>
              </a:solidFill>
              <a:ln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11" name="Elipse 10"/>
              <p:cNvSpPr/>
              <p:nvPr/>
            </p:nvSpPr>
            <p:spPr>
              <a:xfrm>
                <a:off x="2618041" y="6651130"/>
                <a:ext cx="72008" cy="45719"/>
              </a:xfrm>
              <a:prstGeom prst="ellipse">
                <a:avLst/>
              </a:prstGeom>
              <a:solidFill>
                <a:srgbClr val="FFFF00"/>
              </a:solidFill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12" name="Elipse 11"/>
              <p:cNvSpPr/>
              <p:nvPr/>
            </p:nvSpPr>
            <p:spPr>
              <a:xfrm>
                <a:off x="2618041" y="6207174"/>
                <a:ext cx="72008" cy="45719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</p:grpSp>
      <p:sp>
        <p:nvSpPr>
          <p:cNvPr id="13" name="Rectángulo 12"/>
          <p:cNvSpPr/>
          <p:nvPr/>
        </p:nvSpPr>
        <p:spPr>
          <a:xfrm>
            <a:off x="450649" y="744022"/>
            <a:ext cx="12362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es-E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452581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ángulo 4"/>
          <p:cNvSpPr/>
          <p:nvPr/>
        </p:nvSpPr>
        <p:spPr>
          <a:xfrm>
            <a:off x="450649" y="744022"/>
            <a:ext cx="12362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es-E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Rectángulo 5"/>
          <p:cNvSpPr/>
          <p:nvPr/>
        </p:nvSpPr>
        <p:spPr>
          <a:xfrm>
            <a:off x="4376667" y="5617338"/>
            <a:ext cx="72327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400" b="0" i="0" u="none" strike="noStrike" dirty="0" smtClean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ƛ</a:t>
            </a:r>
            <a:r>
              <a:rPr lang="es-ES" sz="1400" b="0" i="0" u="none" strike="noStrike" dirty="0" smtClean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=1.00</a:t>
            </a:r>
            <a:r>
              <a:rPr lang="es-ES" sz="1400" dirty="0" smtClean="0"/>
              <a:t> </a:t>
            </a:r>
            <a:endParaRPr lang="es-ES" sz="1400" dirty="0"/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74570" y="1196340"/>
            <a:ext cx="4594860" cy="44653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824968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 rotWithShape="1">
          <a:blip r:embed="rId2"/>
          <a:srcRect l="9063" t="11370" r="48125" b="48055"/>
          <a:stretch/>
        </p:blipFill>
        <p:spPr>
          <a:xfrm>
            <a:off x="1314450" y="1688949"/>
            <a:ext cx="6054181" cy="3225951"/>
          </a:xfrm>
          <a:prstGeom prst="rect">
            <a:avLst/>
          </a:prstGeom>
        </p:spPr>
      </p:pic>
      <p:sp>
        <p:nvSpPr>
          <p:cNvPr id="3" name="Rectángulo 2"/>
          <p:cNvSpPr/>
          <p:nvPr/>
        </p:nvSpPr>
        <p:spPr>
          <a:xfrm>
            <a:off x="450649" y="744022"/>
            <a:ext cx="12362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endParaRPr lang="es-E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9912798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33</TotalTime>
  <Words>20</Words>
  <Application>Microsoft Office PowerPoint</Application>
  <PresentationFormat>Presentación en pantalla (4:3)</PresentationFormat>
  <Paragraphs>10</Paragraphs>
  <Slides>3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uis Miguel Real</dc:creator>
  <cp:lastModifiedBy>Luis Miguel Real</cp:lastModifiedBy>
  <cp:revision>24</cp:revision>
  <dcterms:created xsi:type="dcterms:W3CDTF">2021-01-07T10:44:00Z</dcterms:created>
  <dcterms:modified xsi:type="dcterms:W3CDTF">2021-07-14T10:37:36Z</dcterms:modified>
</cp:coreProperties>
</file>